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70" r:id="rId2"/>
    <p:sldId id="269" r:id="rId3"/>
    <p:sldId id="271" r:id="rId4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8F8F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651" autoAdjust="0"/>
    <p:restoredTop sz="94660"/>
  </p:normalViewPr>
  <p:slideViewPr>
    <p:cSldViewPr snapToGrid="0">
      <p:cViewPr>
        <p:scale>
          <a:sx n="100" d="100"/>
          <a:sy n="100" d="100"/>
        </p:scale>
        <p:origin x="168" y="1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EFF40AB-0FC4-433E-810A-A7BC19DD83C2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21F3B9-C8F6-42D3-B57E-4B2778E5C41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879436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5E5671B-9B7C-C2C2-6CDA-4E5C7474A78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0F7A80C4-A1A8-00C5-F15E-FE4D4091EAF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91BFF08-458F-75D6-DDD5-B02E4A6359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CE7AF6-B1C7-4C13-87F2-16CBD62A116B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6BAECCA-313A-A25C-9FD1-A2732ECAE0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1C6BC0A-D49E-C3ED-6F1C-F2F2CA86A1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E5E60-1ACD-46F4-8517-37FA84BF910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265261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C1E7E15-1DE7-B0E6-CFA3-0116A31B6B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E05007C8-5852-DA9E-35F9-5F9BEE2139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E11BE73-A3A3-5EEE-D567-1F8CDFE4E7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CE7AF6-B1C7-4C13-87F2-16CBD62A116B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7E26268-B3B4-526B-0B08-3A16B08B5B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46849F4-55CD-6731-7F29-61CC940F94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E5E60-1ACD-46F4-8517-37FA84BF910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008584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4AA1B39F-51EB-5056-7887-BA7EF82E798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DBDBE87C-12D7-5AD6-E89C-C4D2E187D9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F98ADC7-4731-6704-7D0C-B2E9AC6279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CE7AF6-B1C7-4C13-87F2-16CBD62A116B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159A389-4283-115E-AFFE-047C2D1831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D1A3879-8A7F-786B-77B0-2C61577E09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E5E60-1ACD-46F4-8517-37FA84BF910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726944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45B1B8F-FB21-EF34-AF1F-E86D15A35E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28729AB-F57F-7299-F0EE-407FCC7A28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73FE94F-1A4D-8D15-3E48-655F23A535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CE7AF6-B1C7-4C13-87F2-16CBD62A116B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6F595E5-9CC9-6E36-678C-15A08D62F2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CC3429B-32B8-B611-273F-250B0D70A3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E5E60-1ACD-46F4-8517-37FA84BF910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776756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9A19AF1-8F12-4918-AEA2-1520280133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71A940F-7E08-56C9-7292-7EC966B328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D83307E-AB93-C04A-7272-3C2ED46D85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CE7AF6-B1C7-4C13-87F2-16CBD62A116B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AE6EF8A-C6DC-1F3E-1BD5-9BBE82B14E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97209B5-D072-54AE-1B7D-2020723C1E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E5E60-1ACD-46F4-8517-37FA84BF910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351639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AE51C7D-CBBE-C9FB-DC1F-7B7EA8B469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E3B074D0-AF69-2C6F-BB64-9803D5DE2D9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249C10A7-4945-F3F2-3ED0-697032C9E8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76E2E6C-71C8-8DBB-A60B-918FC40E5E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CE7AF6-B1C7-4C13-87F2-16CBD62A116B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6E7247F-6A46-0C51-D6A3-FDC27E1CBB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1EE2AAA-EF34-C226-7FC6-0FA51ACDBD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E5E60-1ACD-46F4-8517-37FA84BF910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767081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BEDC768-1DD5-504F-131B-A7A30038DE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AE3469B2-6BB8-2494-48D8-27EB0461E6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A47B8392-D8E8-CC37-149A-D5051B86FB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667D379C-8571-4A94-4A44-1E3ABF0EE65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9B13228C-F944-B832-0031-0DC0F918193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9A6F0B24-EA04-B191-354A-CD3A40FF45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CE7AF6-B1C7-4C13-87F2-16CBD62A116B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C677CDDD-5F97-E924-2DE2-23AA3BA97C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B4F088DD-1008-E441-4A25-BD740FA30E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E5E60-1ACD-46F4-8517-37FA84BF910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111837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FEFE97C-F567-7000-B331-BD4A129D06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D9EEC4BD-4870-E41D-5945-70CC9C1865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CE7AF6-B1C7-4C13-87F2-16CBD62A116B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3596B0C8-230B-FFB6-19E3-B840015175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CF59A8FF-47D3-C392-BD0F-649B8F813E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E5E60-1ACD-46F4-8517-37FA84BF910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20380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B210C8F4-2D8A-6DED-E760-0379E82B25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CE7AF6-B1C7-4C13-87F2-16CBD62A116B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58545ED0-BCCC-BC22-1740-5A2C3DF31A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8FC1C214-3933-4B04-21F4-AF7F960550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E5E60-1ACD-46F4-8517-37FA84BF910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266215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3C4594E-89CC-8B92-28FE-9EB7E49A5E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A02F229-88FC-F675-E01B-222D3974E78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230E25E2-B5F4-C581-B286-958C1BF79A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D963EF2-058D-F7EF-5A27-53C9CC7828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CE7AF6-B1C7-4C13-87F2-16CBD62A116B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7D21D71-66B9-BF9C-08B3-5BEF8D5F4B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592CDDA-3AEC-5704-B892-363475C399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E5E60-1ACD-46F4-8517-37FA84BF910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159491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BB3C64F-5091-3313-F5DF-0785E4E3CA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B6B43B21-0222-B346-133F-C4D13BB0D2E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1A03C461-D118-CC92-4881-8A601D0E974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5C82CF17-A691-A54A-5069-E0B5A5C7DC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CE7AF6-B1C7-4C13-87F2-16CBD62A116B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2D09F0F-79CE-85B9-C82C-44C6E0CEEF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777F38B3-6271-E836-8685-465DF85BE1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E5E60-1ACD-46F4-8517-37FA84BF910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266245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CF82EDA5-AF9B-C510-E871-5DC8FEE6A8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9F0DB4C-CCE2-5BB2-1D62-41761D331C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DAD3C31-0B3D-BC2B-50F1-A17F2A0ACEB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4CE7AF6-B1C7-4C13-87F2-16CBD62A116B}" type="datetimeFigureOut">
              <a:rPr lang="it-IT" smtClean="0"/>
              <a:t>18/12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5C8FBFD-3850-BA1B-3397-FBD02337B0C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ADEDFC9-BE9A-CB66-0CA0-51F9C718DAA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CCE5E60-1ACD-46F4-8517-37FA84BF910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208533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 descr="Immagine che contiene testo, schermata, diagramma, numero&#10;&#10;Il contenuto generato dall'IA potrebbe non essere corretto.">
            <a:extLst>
              <a:ext uri="{FF2B5EF4-FFF2-40B4-BE49-F238E27FC236}">
                <a16:creationId xmlns:a16="http://schemas.microsoft.com/office/drawing/2014/main" id="{AE052284-2923-6F69-8888-4C42B39B0638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5815"/>
          <a:stretch>
            <a:fillRect/>
          </a:stretch>
        </p:blipFill>
        <p:spPr>
          <a:xfrm>
            <a:off x="1033060" y="1489661"/>
            <a:ext cx="6630325" cy="2826277"/>
          </a:xfrm>
          <a:prstGeom prst="rect">
            <a:avLst/>
          </a:prstGeom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6AA59123-087D-9D3D-E6D1-7247D69DBD12}"/>
              </a:ext>
            </a:extLst>
          </p:cNvPr>
          <p:cNvSpPr txBox="1"/>
          <p:nvPr/>
        </p:nvSpPr>
        <p:spPr>
          <a:xfrm>
            <a:off x="544010" y="277792"/>
            <a:ext cx="1944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S1 NK </a:t>
            </a:r>
            <a:r>
              <a:rPr lang="it-IT" dirty="0" err="1"/>
              <a:t>cell</a:t>
            </a:r>
            <a:r>
              <a:rPr lang="it-IT" dirty="0"/>
              <a:t> </a:t>
            </a:r>
            <a:r>
              <a:rPr lang="it-IT" dirty="0" err="1"/>
              <a:t>purity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2455910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uppo 8">
            <a:extLst>
              <a:ext uri="{FF2B5EF4-FFF2-40B4-BE49-F238E27FC236}">
                <a16:creationId xmlns:a16="http://schemas.microsoft.com/office/drawing/2014/main" id="{1F7ADBB5-E5BD-6253-B146-451CC7AC4103}"/>
              </a:ext>
            </a:extLst>
          </p:cNvPr>
          <p:cNvGrpSpPr/>
          <p:nvPr/>
        </p:nvGrpSpPr>
        <p:grpSpPr>
          <a:xfrm>
            <a:off x="556260" y="1074420"/>
            <a:ext cx="3363505" cy="2856746"/>
            <a:chOff x="5875020" y="2103120"/>
            <a:chExt cx="3363505" cy="2856746"/>
          </a:xfrm>
        </p:grpSpPr>
        <p:pic>
          <p:nvPicPr>
            <p:cNvPr id="7" name="Immagine 6" descr="Immagine che contiene testo, diagramma, schermata, Carattere&#10;&#10;Il contenuto generato dall'IA potrebbe non essere corretto.">
              <a:extLst>
                <a:ext uri="{FF2B5EF4-FFF2-40B4-BE49-F238E27FC236}">
                  <a16:creationId xmlns:a16="http://schemas.microsoft.com/office/drawing/2014/main" id="{719A0761-D0B4-9246-0416-71A649B8FA1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t="424"/>
            <a:stretch>
              <a:fillRect/>
            </a:stretch>
          </p:blipFill>
          <p:spPr>
            <a:xfrm>
              <a:off x="5970994" y="2123572"/>
              <a:ext cx="3267531" cy="2836294"/>
            </a:xfrm>
            <a:prstGeom prst="rect">
              <a:avLst/>
            </a:prstGeom>
          </p:spPr>
        </p:pic>
        <p:sp>
          <p:nvSpPr>
            <p:cNvPr id="8" name="Rettangolo 7">
              <a:extLst>
                <a:ext uri="{FF2B5EF4-FFF2-40B4-BE49-F238E27FC236}">
                  <a16:creationId xmlns:a16="http://schemas.microsoft.com/office/drawing/2014/main" id="{6CD11842-85ED-4585-09E9-02E059791886}"/>
                </a:ext>
              </a:extLst>
            </p:cNvPr>
            <p:cNvSpPr/>
            <p:nvPr/>
          </p:nvSpPr>
          <p:spPr>
            <a:xfrm>
              <a:off x="5875020" y="2103120"/>
              <a:ext cx="3363505" cy="4572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A26F4E37-6FCA-A7E9-D19D-C2CA3FAA936E}"/>
              </a:ext>
            </a:extLst>
          </p:cNvPr>
          <p:cNvSpPr txBox="1"/>
          <p:nvPr/>
        </p:nvSpPr>
        <p:spPr>
          <a:xfrm>
            <a:off x="652234" y="330407"/>
            <a:ext cx="609407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dirty="0"/>
              <a:t>S2 </a:t>
            </a:r>
            <a:r>
              <a:rPr lang="it-IT" dirty="0" err="1"/>
              <a:t>Viability</a:t>
            </a:r>
            <a:r>
              <a:rPr lang="it-IT" dirty="0"/>
              <a:t> of NK </a:t>
            </a:r>
            <a:r>
              <a:rPr lang="it-IT" dirty="0" err="1"/>
              <a:t>cells</a:t>
            </a:r>
            <a:r>
              <a:rPr lang="it-IT" dirty="0"/>
              <a:t> </a:t>
            </a:r>
            <a:r>
              <a:rPr lang="it-IT" dirty="0" err="1"/>
              <a:t>without</a:t>
            </a:r>
            <a:r>
              <a:rPr lang="it-IT" dirty="0"/>
              <a:t> IL-15 </a:t>
            </a:r>
            <a:r>
              <a:rPr lang="it-IT" dirty="0" err="1"/>
              <a:t>at</a:t>
            </a:r>
            <a:r>
              <a:rPr lang="it-IT" dirty="0"/>
              <a:t> day 7</a:t>
            </a:r>
          </a:p>
        </p:txBody>
      </p:sp>
      <p:grpSp>
        <p:nvGrpSpPr>
          <p:cNvPr id="5" name="Gruppo 4">
            <a:extLst>
              <a:ext uri="{FF2B5EF4-FFF2-40B4-BE49-F238E27FC236}">
                <a16:creationId xmlns:a16="http://schemas.microsoft.com/office/drawing/2014/main" id="{31BAF958-0F36-C819-FEA4-37E8CE6DE281}"/>
              </a:ext>
            </a:extLst>
          </p:cNvPr>
          <p:cNvGrpSpPr/>
          <p:nvPr/>
        </p:nvGrpSpPr>
        <p:grpSpPr>
          <a:xfrm>
            <a:off x="4156267" y="1120140"/>
            <a:ext cx="3267531" cy="2836294"/>
            <a:chOff x="8103427" y="1114068"/>
            <a:chExt cx="3343742" cy="2926904"/>
          </a:xfrm>
        </p:grpSpPr>
        <p:pic>
          <p:nvPicPr>
            <p:cNvPr id="3" name="Immagine 2" descr="Immagine che contiene testo, schermata, diagramma, Carattere&#10;&#10;Il contenuto generato dall'IA potrebbe non essere corretto.">
              <a:extLst>
                <a:ext uri="{FF2B5EF4-FFF2-40B4-BE49-F238E27FC236}">
                  <a16:creationId xmlns:a16="http://schemas.microsoft.com/office/drawing/2014/main" id="{4D92EA8F-FA69-7D2F-D61F-AB288C244F0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t="4484"/>
            <a:stretch>
              <a:fillRect/>
            </a:stretch>
          </p:blipFill>
          <p:spPr>
            <a:xfrm>
              <a:off x="8103427" y="1120140"/>
              <a:ext cx="3343742" cy="2920832"/>
            </a:xfrm>
            <a:prstGeom prst="rect">
              <a:avLst/>
            </a:prstGeom>
          </p:spPr>
        </p:pic>
        <p:sp>
          <p:nvSpPr>
            <p:cNvPr id="4" name="Rettangolo 3">
              <a:extLst>
                <a:ext uri="{FF2B5EF4-FFF2-40B4-BE49-F238E27FC236}">
                  <a16:creationId xmlns:a16="http://schemas.microsoft.com/office/drawing/2014/main" id="{D2341C61-6CF4-F243-211C-97BD42A3791F}"/>
                </a:ext>
              </a:extLst>
            </p:cNvPr>
            <p:cNvSpPr/>
            <p:nvPr/>
          </p:nvSpPr>
          <p:spPr>
            <a:xfrm>
              <a:off x="8819909" y="1114068"/>
              <a:ext cx="2523282" cy="45720"/>
            </a:xfrm>
            <a:prstGeom prst="rect">
              <a:avLst/>
            </a:prstGeom>
            <a:solidFill>
              <a:srgbClr val="F8F8F8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</p:spTree>
    <p:extLst>
      <p:ext uri="{BB962C8B-B14F-4D97-AF65-F5344CB8AC3E}">
        <p14:creationId xmlns:p14="http://schemas.microsoft.com/office/powerpoint/2010/main" val="11930709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 descr="Immagine che contiene testo, schermata, diagramma, linea&#10;&#10;Il contenuto generato dall'IA potrebbe non essere corretto.">
            <a:extLst>
              <a:ext uri="{FF2B5EF4-FFF2-40B4-BE49-F238E27FC236}">
                <a16:creationId xmlns:a16="http://schemas.microsoft.com/office/drawing/2014/main" id="{0499F8A0-69EA-8161-1974-03905C619E74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637" b="-1"/>
          <a:stretch>
            <a:fillRect/>
          </a:stretch>
        </p:blipFill>
        <p:spPr>
          <a:xfrm>
            <a:off x="802728" y="1388538"/>
            <a:ext cx="3286584" cy="2972215"/>
          </a:xfrm>
          <a:prstGeom prst="rect">
            <a:avLst/>
          </a:prstGeom>
        </p:spPr>
      </p:pic>
      <p:pic>
        <p:nvPicPr>
          <p:cNvPr id="5" name="Immagine 4" descr="Immagine che contiene testo, schermata, diagramma, linea&#10;&#10;Il contenuto generato dall'IA potrebbe non essere corretto.">
            <a:extLst>
              <a:ext uri="{FF2B5EF4-FFF2-40B4-BE49-F238E27FC236}">
                <a16:creationId xmlns:a16="http://schemas.microsoft.com/office/drawing/2014/main" id="{109DBFC1-4386-0976-E953-DD696181438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36496" y="1388538"/>
            <a:ext cx="3381847" cy="2972215"/>
          </a:xfrm>
          <a:prstGeom prst="rect">
            <a:avLst/>
          </a:prstGeom>
        </p:spPr>
      </p:pic>
      <p:sp>
        <p:nvSpPr>
          <p:cNvPr id="7" name="CasellaDiTesto 6">
            <a:extLst>
              <a:ext uri="{FF2B5EF4-FFF2-40B4-BE49-F238E27FC236}">
                <a16:creationId xmlns:a16="http://schemas.microsoft.com/office/drawing/2014/main" id="{9871219E-DC55-F54E-4A7F-E07CA020B4A9}"/>
              </a:ext>
            </a:extLst>
          </p:cNvPr>
          <p:cNvSpPr txBox="1"/>
          <p:nvPr/>
        </p:nvSpPr>
        <p:spPr>
          <a:xfrm>
            <a:off x="802728" y="376706"/>
            <a:ext cx="609407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dirty="0"/>
              <a:t>S3 CD107a </a:t>
            </a:r>
            <a:r>
              <a:rPr lang="it-IT" dirty="0" err="1"/>
              <a:t>expression</a:t>
            </a:r>
            <a:r>
              <a:rPr lang="it-IT" dirty="0"/>
              <a:t> on NK cells+IL15 </a:t>
            </a:r>
            <a:r>
              <a:rPr lang="it-IT" dirty="0" err="1"/>
              <a:t>at</a:t>
            </a:r>
            <a:r>
              <a:rPr lang="it-IT" dirty="0"/>
              <a:t> day7 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FEF8FA04-D8CB-4C4E-507F-51FCFB8551DD}"/>
              </a:ext>
            </a:extLst>
          </p:cNvPr>
          <p:cNvSpPr txBox="1"/>
          <p:nvPr/>
        </p:nvSpPr>
        <p:spPr>
          <a:xfrm>
            <a:off x="2213659" y="4360753"/>
            <a:ext cx="64528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dirty="0"/>
              <a:t>NK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CAD70BD3-00ED-8B87-FFBD-F98A5F15FA7E}"/>
              </a:ext>
            </a:extLst>
          </p:cNvPr>
          <p:cNvSpPr txBox="1"/>
          <p:nvPr/>
        </p:nvSpPr>
        <p:spPr>
          <a:xfrm>
            <a:off x="5772776" y="4360753"/>
            <a:ext cx="124148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dirty="0"/>
              <a:t>NK+A549s</a:t>
            </a:r>
          </a:p>
        </p:txBody>
      </p:sp>
      <p:sp>
        <p:nvSpPr>
          <p:cNvPr id="11" name="Rettangolo 10">
            <a:extLst>
              <a:ext uri="{FF2B5EF4-FFF2-40B4-BE49-F238E27FC236}">
                <a16:creationId xmlns:a16="http://schemas.microsoft.com/office/drawing/2014/main" id="{B26C0E3B-613B-BBF3-1280-4D0AFDC76411}"/>
              </a:ext>
            </a:extLst>
          </p:cNvPr>
          <p:cNvSpPr/>
          <p:nvPr/>
        </p:nvSpPr>
        <p:spPr>
          <a:xfrm>
            <a:off x="4340503" y="1366396"/>
            <a:ext cx="3381847" cy="1273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2" name="Rettangolo 11">
            <a:extLst>
              <a:ext uri="{FF2B5EF4-FFF2-40B4-BE49-F238E27FC236}">
                <a16:creationId xmlns:a16="http://schemas.microsoft.com/office/drawing/2014/main" id="{518C5D3F-B84C-78FD-F2B8-16610FFC1D22}"/>
              </a:ext>
            </a:extLst>
          </p:cNvPr>
          <p:cNvSpPr/>
          <p:nvPr/>
        </p:nvSpPr>
        <p:spPr>
          <a:xfrm>
            <a:off x="707465" y="1332309"/>
            <a:ext cx="3381847" cy="1273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5026598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855</TotalTime>
  <Words>28</Words>
  <Application>Microsoft Office PowerPoint</Application>
  <PresentationFormat>Widescreen</PresentationFormat>
  <Paragraphs>5</Paragraphs>
  <Slides>3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Tema di Office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Ilaria Roato</dc:creator>
  <cp:lastModifiedBy>Ilaria Roato</cp:lastModifiedBy>
  <cp:revision>70</cp:revision>
  <dcterms:created xsi:type="dcterms:W3CDTF">2024-08-27T14:43:45Z</dcterms:created>
  <dcterms:modified xsi:type="dcterms:W3CDTF">2025-12-18T08:22:17Z</dcterms:modified>
</cp:coreProperties>
</file>